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02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1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254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4041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6993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043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9022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677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0924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4059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7230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8799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53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94B94-0874-438C-84FF-2337F8F8F97D}" type="datetimeFigureOut">
              <a:rPr lang="de-DE" smtClean="0"/>
              <a:t>04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CFCA3-33BB-4AFA-B8C7-61CEB3B5C8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378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651" y="3984593"/>
            <a:ext cx="2888135" cy="2525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1"/>
          <p:cNvSpPr txBox="1">
            <a:spLocks noChangeArrowheads="1"/>
          </p:cNvSpPr>
          <p:nvPr/>
        </p:nvSpPr>
        <p:spPr bwMode="auto">
          <a:xfrm>
            <a:off x="55014" y="6465195"/>
            <a:ext cx="2952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est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X-ray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  <a:r>
              <a:rPr lang="en-GB" alt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03.2020</a:t>
            </a:r>
            <a:endParaRPr lang="en-GB" alt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9853" y="3978259"/>
            <a:ext cx="2608665" cy="2525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feld 1"/>
          <p:cNvSpPr txBox="1">
            <a:spLocks noChangeArrowheads="1"/>
          </p:cNvSpPr>
          <p:nvPr/>
        </p:nvSpPr>
        <p:spPr bwMode="auto">
          <a:xfrm>
            <a:off x="2920909" y="6465864"/>
            <a:ext cx="2952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est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X-ray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5</a:t>
            </a:r>
            <a:r>
              <a:rPr lang="en-GB" alt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03.2020</a:t>
            </a:r>
            <a:endParaRPr lang="en-GB" alt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4244" y="3978259"/>
            <a:ext cx="3574132" cy="2525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feld 1"/>
          <p:cNvSpPr txBox="1">
            <a:spLocks noChangeArrowheads="1"/>
          </p:cNvSpPr>
          <p:nvPr/>
        </p:nvSpPr>
        <p:spPr bwMode="auto">
          <a:xfrm>
            <a:off x="6057476" y="6457314"/>
            <a:ext cx="2952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est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X-ray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5</a:t>
            </a:r>
            <a:r>
              <a:rPr lang="en-GB" alt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03.2020</a:t>
            </a:r>
            <a:endParaRPr lang="en-GB" alt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1" r="3710"/>
          <a:stretch/>
        </p:blipFill>
        <p:spPr bwMode="auto">
          <a:xfrm>
            <a:off x="4230796" y="1058740"/>
            <a:ext cx="3674090" cy="25436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6" t="3160" r="2722"/>
          <a:stretch/>
        </p:blipFill>
        <p:spPr bwMode="auto">
          <a:xfrm>
            <a:off x="414761" y="1056821"/>
            <a:ext cx="3764254" cy="237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0" r="3827"/>
          <a:stretch/>
        </p:blipFill>
        <p:spPr bwMode="auto">
          <a:xfrm>
            <a:off x="7968567" y="1058740"/>
            <a:ext cx="3696631" cy="25436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feld 1"/>
          <p:cNvSpPr txBox="1">
            <a:spLocks noChangeArrowheads="1"/>
          </p:cNvSpPr>
          <p:nvPr/>
        </p:nvSpPr>
        <p:spPr bwMode="auto">
          <a:xfrm>
            <a:off x="1842334" y="3587971"/>
            <a:ext cx="87489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-----------------------------   CT-scan 10.0</a:t>
            </a:r>
            <a:r>
              <a:rPr lang="en-GB" alt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2020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------------------------------ </a:t>
            </a:r>
            <a:endParaRPr lang="en-GB" alt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52708" y="3986140"/>
            <a:ext cx="2777666" cy="2479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feld 1"/>
          <p:cNvSpPr txBox="1">
            <a:spLocks noChangeArrowheads="1"/>
          </p:cNvSpPr>
          <p:nvPr/>
        </p:nvSpPr>
        <p:spPr bwMode="auto">
          <a:xfrm>
            <a:off x="9237910" y="6465195"/>
            <a:ext cx="29520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GB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ochoscopy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5</a:t>
            </a:r>
            <a:r>
              <a:rPr lang="en-GB" alt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03.2020</a:t>
            </a:r>
            <a:endParaRPr lang="en-GB" alt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375859" y="1068040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211532" y="1060194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7953957" y="1067322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67893" y="3958555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3020423" y="3940799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684213" y="3938309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9310033" y="3951188"/>
            <a:ext cx="4378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8" name="Textfeld 3"/>
          <p:cNvSpPr txBox="1">
            <a:spLocks noChangeArrowheads="1"/>
          </p:cNvSpPr>
          <p:nvPr/>
        </p:nvSpPr>
        <p:spPr bwMode="auto">
          <a:xfrm>
            <a:off x="360000" y="108000"/>
            <a:ext cx="114480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CT-scan, Chest X-rays, an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ronch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­alveolar lavage (BAL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AML patient with Covid-19 infection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-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T scans of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lun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ed atypical pneumonia in the lower lobes, predominantly of the lef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d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– (F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est X-rays at different time point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y of AML diagnoses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ay before start of chemotherapy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after PCR positivity for SARS-CoV-2 was detected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roncho­alveolar lavage (BAL) was performed and demonstrated an inflammation and areas with signs of small bleeding. Microbiological and viral analysis detected no other viruses or growing bacteri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56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Breitbild</PresentationFormat>
  <Paragraphs>1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Universitätsklinikum Ul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lies Götz</dc:creator>
  <cp:lastModifiedBy>Marlies Götz</cp:lastModifiedBy>
  <cp:revision>157</cp:revision>
  <cp:lastPrinted>2020-04-28T12:01:04Z</cp:lastPrinted>
  <dcterms:created xsi:type="dcterms:W3CDTF">2020-04-16T08:31:58Z</dcterms:created>
  <dcterms:modified xsi:type="dcterms:W3CDTF">2020-09-04T12:00:43Z</dcterms:modified>
</cp:coreProperties>
</file>